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Late-adolescent weight categories and early kidney disease in young adulthood: a nationwide study of Arab and Jewish Israel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89759"/>
            <a:ext cx="12018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dolescent obesity has a different impact on the development of early CKD in Arab and Jewish ethnicities in Israel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reister-Goltzman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 strong dose-response association was observed between excess weight in adolescence and early CKD in young adulthood (≤ 30 years), particularly among Arab adolescents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4F987CB-2430-D917-078A-5087B152DD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964" y="4202617"/>
            <a:ext cx="512108" cy="104860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51A10F9-6448-315F-1E13-9260863270C1}"/>
              </a:ext>
            </a:extLst>
          </p:cNvPr>
          <p:cNvSpPr txBox="1"/>
          <p:nvPr/>
        </p:nvSpPr>
        <p:spPr>
          <a:xfrm>
            <a:off x="293914" y="2145317"/>
            <a:ext cx="20535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srgbClr val="AA0065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dolescents aged 17-19 years: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263A62F-DC41-021D-1E30-500E26B1CB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964" y="2771536"/>
            <a:ext cx="512108" cy="104860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7481D44-0F8E-EDDF-6FF0-726C58563B00}"/>
              </a:ext>
            </a:extLst>
          </p:cNvPr>
          <p:cNvSpPr txBox="1"/>
          <p:nvPr/>
        </p:nvSpPr>
        <p:spPr>
          <a:xfrm>
            <a:off x="796071" y="2895727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47,892 Jewis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1E92D1-4116-645E-62DB-0FA0E7DEADA0}"/>
              </a:ext>
            </a:extLst>
          </p:cNvPr>
          <p:cNvSpPr txBox="1"/>
          <p:nvPr/>
        </p:nvSpPr>
        <p:spPr>
          <a:xfrm>
            <a:off x="781660" y="478745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53,492 Arab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9BBC1A0E-0E69-37D3-4BC3-86A05AD147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1510" y="3382952"/>
            <a:ext cx="755970" cy="62184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5869282-A6D4-8F4F-7A06-8A51D69FFC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9098" y="4176111"/>
            <a:ext cx="898382" cy="611348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A3F01D86-F479-2FF5-8CC1-9219A131BE50}"/>
              </a:ext>
            </a:extLst>
          </p:cNvPr>
          <p:cNvSpPr/>
          <p:nvPr/>
        </p:nvSpPr>
        <p:spPr>
          <a:xfrm>
            <a:off x="2472490" y="1753092"/>
            <a:ext cx="3882434" cy="897252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Outcome: urine albumin-to-creatinine ratio ≥30 mg/g, eGFR test ≥ 60 mL/min/1.73 m2</a:t>
            </a:r>
            <a:endParaRPr lang="en-GB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F4D48F0-3349-F5EE-49FD-DBEFD7070F8F}"/>
              </a:ext>
            </a:extLst>
          </p:cNvPr>
          <p:cNvSpPr/>
          <p:nvPr/>
        </p:nvSpPr>
        <p:spPr>
          <a:xfrm>
            <a:off x="2453986" y="2913590"/>
            <a:ext cx="4031312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ensoring: death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3F8A2C3-7C97-6D5A-2518-8D355035D988}"/>
              </a:ext>
            </a:extLst>
          </p:cNvPr>
          <p:cNvSpPr/>
          <p:nvPr/>
        </p:nvSpPr>
        <p:spPr>
          <a:xfrm>
            <a:off x="2453986" y="3767077"/>
            <a:ext cx="4031312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ensoring: discontinuation of insurance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B880AFC-F08E-619D-9B6A-13E1F0312340}"/>
              </a:ext>
            </a:extLst>
          </p:cNvPr>
          <p:cNvSpPr/>
          <p:nvPr/>
        </p:nvSpPr>
        <p:spPr>
          <a:xfrm>
            <a:off x="2472490" y="4668793"/>
            <a:ext cx="4031312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ge 30 years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D01E8F91-6FBD-2912-749F-141533A02CA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887" r="2080" b="26209"/>
          <a:stretch>
            <a:fillRect/>
          </a:stretch>
        </p:blipFill>
        <p:spPr>
          <a:xfrm>
            <a:off x="6551529" y="1686393"/>
            <a:ext cx="5493274" cy="337649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FD44F36-56FD-4043-D283-867AF1FCEE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02432" y="2174345"/>
            <a:ext cx="512108" cy="1048603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27210BCA-1751-9322-902C-45C64DFBD7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7754" y="2174345"/>
            <a:ext cx="512108" cy="1048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11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Bob Thompson</dc:creator>
  <cp:lastModifiedBy>Bob Thompson</cp:lastModifiedBy>
  <cp:revision>64</cp:revision>
  <dcterms:created xsi:type="dcterms:W3CDTF">2019-06-13T12:30:18Z</dcterms:created>
  <dcterms:modified xsi:type="dcterms:W3CDTF">2026-01-30T20:48:21Z</dcterms:modified>
</cp:coreProperties>
</file>